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710" y="-78"/>
      </p:cViewPr>
      <p:guideLst>
        <p:guide orient="horz"/>
        <p:guide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FD63E-5833-4BBC-8DBC-14AA9F4AEA85}" type="datetimeFigureOut">
              <a:rPr lang="en-GB" smtClean="0"/>
              <a:t>09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2E87D-F566-4975-9F68-4B6EF5A96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55014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FD63E-5833-4BBC-8DBC-14AA9F4AEA85}" type="datetimeFigureOut">
              <a:rPr lang="en-GB" smtClean="0"/>
              <a:t>09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2E87D-F566-4975-9F68-4B6EF5A96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31733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FD63E-5833-4BBC-8DBC-14AA9F4AEA85}" type="datetimeFigureOut">
              <a:rPr lang="en-GB" smtClean="0"/>
              <a:t>09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2E87D-F566-4975-9F68-4B6EF5A96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98696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FD63E-5833-4BBC-8DBC-14AA9F4AEA85}" type="datetimeFigureOut">
              <a:rPr lang="en-GB" smtClean="0"/>
              <a:t>09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2E87D-F566-4975-9F68-4B6EF5A96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99157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FD63E-5833-4BBC-8DBC-14AA9F4AEA85}" type="datetimeFigureOut">
              <a:rPr lang="en-GB" smtClean="0"/>
              <a:t>09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2E87D-F566-4975-9F68-4B6EF5A96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55071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FD63E-5833-4BBC-8DBC-14AA9F4AEA85}" type="datetimeFigureOut">
              <a:rPr lang="en-GB" smtClean="0"/>
              <a:t>09/11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2E87D-F566-4975-9F68-4B6EF5A96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65543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FD63E-5833-4BBC-8DBC-14AA9F4AEA85}" type="datetimeFigureOut">
              <a:rPr lang="en-GB" smtClean="0"/>
              <a:t>09/11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2E87D-F566-4975-9F68-4B6EF5A96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79040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FD63E-5833-4BBC-8DBC-14AA9F4AEA85}" type="datetimeFigureOut">
              <a:rPr lang="en-GB" smtClean="0"/>
              <a:t>09/11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2E87D-F566-4975-9F68-4B6EF5A96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12179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FD63E-5833-4BBC-8DBC-14AA9F4AEA85}" type="datetimeFigureOut">
              <a:rPr lang="en-GB" smtClean="0"/>
              <a:t>09/11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2E87D-F566-4975-9F68-4B6EF5A96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251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FD63E-5833-4BBC-8DBC-14AA9F4AEA85}" type="datetimeFigureOut">
              <a:rPr lang="en-GB" smtClean="0"/>
              <a:t>09/11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2E87D-F566-4975-9F68-4B6EF5A96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28178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FD63E-5833-4BBC-8DBC-14AA9F4AEA85}" type="datetimeFigureOut">
              <a:rPr lang="en-GB" smtClean="0"/>
              <a:t>09/11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2E87D-F566-4975-9F68-4B6EF5A96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60420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BFD63E-5833-4BBC-8DBC-14AA9F4AEA85}" type="datetimeFigureOut">
              <a:rPr lang="en-GB" smtClean="0"/>
              <a:t>09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02E87D-F566-4975-9F68-4B6EF5A96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30507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/>
          <p:cNvGrpSpPr/>
          <p:nvPr/>
        </p:nvGrpSpPr>
        <p:grpSpPr>
          <a:xfrm>
            <a:off x="5100869" y="590242"/>
            <a:ext cx="3719603" cy="3287729"/>
            <a:chOff x="4308781" y="590242"/>
            <a:chExt cx="3719603" cy="3287729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 rotWithShape="1">
            <a:blip r:embed="rId2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512" t="31398" r="28907" b="49314"/>
            <a:stretch/>
          </p:blipFill>
          <p:spPr bwMode="auto">
            <a:xfrm rot="10800000" flipH="1">
              <a:off x="4737782" y="1844825"/>
              <a:ext cx="3290602" cy="196734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7" name="Group 16"/>
            <p:cNvGrpSpPr/>
            <p:nvPr/>
          </p:nvGrpSpPr>
          <p:grpSpPr>
            <a:xfrm>
              <a:off x="4704894" y="590242"/>
              <a:ext cx="3205635" cy="1342034"/>
              <a:chOff x="507468" y="588449"/>
              <a:chExt cx="3205635" cy="1342034"/>
            </a:xfrm>
          </p:grpSpPr>
          <p:sp>
            <p:nvSpPr>
              <p:cNvPr id="18" name="TextBox 17"/>
              <p:cNvSpPr txBox="1"/>
              <p:nvPr/>
            </p:nvSpPr>
            <p:spPr>
              <a:xfrm>
                <a:off x="507468" y="1430433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M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 rot="17687739">
                <a:off x="575928" y="1120966"/>
                <a:ext cx="13420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err="1" smtClean="0">
                    <a:latin typeface="Arial" pitchFamily="34" charset="0"/>
                    <a:cs typeface="Arial" pitchFamily="34" charset="0"/>
                  </a:rPr>
                  <a:t>Uninduced</a:t>
                </a:r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 Cells 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 rot="17687739">
                <a:off x="946749" y="1186161"/>
                <a:ext cx="115608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Induced Cells 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 rot="17687739">
                <a:off x="1676850" y="1302311"/>
                <a:ext cx="94288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Ni </a:t>
                </a:r>
                <a:r>
                  <a:rPr lang="en-GB" sz="1200" baseline="30000" dirty="0" smtClean="0">
                    <a:latin typeface="Arial" pitchFamily="34" charset="0"/>
                    <a:cs typeface="Arial" pitchFamily="34" charset="0"/>
                  </a:rPr>
                  <a:t>2+</a:t>
                </a:r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 Flow  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 rot="17687739">
                <a:off x="1302577" y="1264456"/>
                <a:ext cx="101341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Cell Extract 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 rot="17687739">
                <a:off x="1951891" y="1282899"/>
                <a:ext cx="100610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Ni </a:t>
                </a:r>
                <a:r>
                  <a:rPr lang="en-GB" sz="1200" baseline="30000" dirty="0" smtClean="0">
                    <a:latin typeface="Arial" pitchFamily="34" charset="0"/>
                    <a:cs typeface="Arial" pitchFamily="34" charset="0"/>
                  </a:rPr>
                  <a:t>2+</a:t>
                </a:r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 Wash  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2771800" y="1368713"/>
                <a:ext cx="65274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Elution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5" name="Straight Connector 24"/>
              <p:cNvCxnSpPr/>
              <p:nvPr/>
            </p:nvCxnSpPr>
            <p:spPr>
              <a:xfrm>
                <a:off x="2453103" y="1700808"/>
                <a:ext cx="126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Group 25"/>
            <p:cNvGrpSpPr/>
            <p:nvPr/>
          </p:nvGrpSpPr>
          <p:grpSpPr>
            <a:xfrm>
              <a:off x="4308781" y="1419244"/>
              <a:ext cx="477025" cy="2458727"/>
              <a:chOff x="198165" y="4004325"/>
              <a:chExt cx="477025" cy="2458727"/>
            </a:xfrm>
          </p:grpSpPr>
          <p:sp>
            <p:nvSpPr>
              <p:cNvPr id="28" name="TextBox 27"/>
              <p:cNvSpPr txBox="1"/>
              <p:nvPr/>
            </p:nvSpPr>
            <p:spPr>
              <a:xfrm>
                <a:off x="218014" y="4004325"/>
                <a:ext cx="45717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err="1" smtClean="0">
                    <a:latin typeface="Arial" pitchFamily="34" charset="0"/>
                    <a:cs typeface="Arial" pitchFamily="34" charset="0"/>
                  </a:rPr>
                  <a:t>kDa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9" name="Straight Connector 28"/>
              <p:cNvCxnSpPr/>
              <p:nvPr/>
            </p:nvCxnSpPr>
            <p:spPr>
              <a:xfrm>
                <a:off x="512688" y="5579247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/>
              <p:cNvCxnSpPr/>
              <p:nvPr/>
            </p:nvCxnSpPr>
            <p:spPr>
              <a:xfrm>
                <a:off x="512688" y="5914904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/>
              <p:cNvCxnSpPr/>
              <p:nvPr/>
            </p:nvCxnSpPr>
            <p:spPr>
              <a:xfrm>
                <a:off x="512688" y="6309717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Straight Connector 31"/>
              <p:cNvCxnSpPr/>
              <p:nvPr/>
            </p:nvCxnSpPr>
            <p:spPr>
              <a:xfrm>
                <a:off x="512688" y="5120354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TextBox 32"/>
              <p:cNvSpPr txBox="1"/>
              <p:nvPr/>
            </p:nvSpPr>
            <p:spPr>
              <a:xfrm>
                <a:off x="260648" y="5004048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66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260648" y="5417046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45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260648" y="5767561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35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260648" y="6186053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25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37" name="Straight Connector 36"/>
              <p:cNvCxnSpPr/>
              <p:nvPr/>
            </p:nvCxnSpPr>
            <p:spPr>
              <a:xfrm>
                <a:off x="512688" y="4778499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" name="TextBox 37"/>
              <p:cNvSpPr txBox="1"/>
              <p:nvPr/>
            </p:nvSpPr>
            <p:spPr>
              <a:xfrm>
                <a:off x="198165" y="4644008"/>
                <a:ext cx="42813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116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15" name="Group 14"/>
          <p:cNvGrpSpPr/>
          <p:nvPr/>
        </p:nvGrpSpPr>
        <p:grpSpPr>
          <a:xfrm>
            <a:off x="86586" y="588449"/>
            <a:ext cx="3693326" cy="3221550"/>
            <a:chOff x="86586" y="588449"/>
            <a:chExt cx="3693326" cy="3221550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210" t="36049" r="26970" b="44700"/>
            <a:stretch/>
          </p:blipFill>
          <p:spPr bwMode="auto">
            <a:xfrm rot="10800000">
              <a:off x="539750" y="1842654"/>
              <a:ext cx="3240162" cy="196734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4" name="Group 13"/>
            <p:cNvGrpSpPr/>
            <p:nvPr/>
          </p:nvGrpSpPr>
          <p:grpSpPr>
            <a:xfrm>
              <a:off x="507468" y="588449"/>
              <a:ext cx="3205635" cy="1342034"/>
              <a:chOff x="507468" y="588449"/>
              <a:chExt cx="3205635" cy="1342034"/>
            </a:xfrm>
          </p:grpSpPr>
          <p:sp>
            <p:nvSpPr>
              <p:cNvPr id="6" name="TextBox 5"/>
              <p:cNvSpPr txBox="1"/>
              <p:nvPr/>
            </p:nvSpPr>
            <p:spPr>
              <a:xfrm>
                <a:off x="507468" y="1430433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M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 rot="17687739">
                <a:off x="589783" y="1120966"/>
                <a:ext cx="13420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err="1" smtClean="0">
                    <a:latin typeface="Arial" pitchFamily="34" charset="0"/>
                    <a:cs typeface="Arial" pitchFamily="34" charset="0"/>
                  </a:rPr>
                  <a:t>Uninduced</a:t>
                </a:r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 Cells 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 rot="17687739">
                <a:off x="1016024" y="1186161"/>
                <a:ext cx="115608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Induced Cells 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 rot="17687739">
                <a:off x="1676850" y="1302311"/>
                <a:ext cx="94288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Ni </a:t>
                </a:r>
                <a:r>
                  <a:rPr lang="en-GB" sz="1200" baseline="30000" dirty="0" smtClean="0">
                    <a:latin typeface="Arial" pitchFamily="34" charset="0"/>
                    <a:cs typeface="Arial" pitchFamily="34" charset="0"/>
                  </a:rPr>
                  <a:t>2+</a:t>
                </a:r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 Flow  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 rot="17687739">
                <a:off x="1357997" y="1264456"/>
                <a:ext cx="101341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Cell Extract 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 rot="17687739">
                <a:off x="1924181" y="1282899"/>
                <a:ext cx="100610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Ni </a:t>
                </a:r>
                <a:r>
                  <a:rPr lang="en-GB" sz="1200" baseline="30000" dirty="0" smtClean="0">
                    <a:latin typeface="Arial" pitchFamily="34" charset="0"/>
                    <a:cs typeface="Arial" pitchFamily="34" charset="0"/>
                  </a:rPr>
                  <a:t>2+</a:t>
                </a:r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 Wash  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2771800" y="1368713"/>
                <a:ext cx="65274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Elution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4" name="Straight Connector 3"/>
              <p:cNvCxnSpPr/>
              <p:nvPr/>
            </p:nvCxnSpPr>
            <p:spPr>
              <a:xfrm>
                <a:off x="2453103" y="1700808"/>
                <a:ext cx="126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" name="Group 38"/>
            <p:cNvGrpSpPr/>
            <p:nvPr/>
          </p:nvGrpSpPr>
          <p:grpSpPr>
            <a:xfrm>
              <a:off x="86586" y="1388801"/>
              <a:ext cx="477025" cy="2389452"/>
              <a:chOff x="198165" y="4073600"/>
              <a:chExt cx="477025" cy="2389452"/>
            </a:xfrm>
          </p:grpSpPr>
          <p:sp>
            <p:nvSpPr>
              <p:cNvPr id="41" name="TextBox 40"/>
              <p:cNvSpPr txBox="1"/>
              <p:nvPr/>
            </p:nvSpPr>
            <p:spPr>
              <a:xfrm>
                <a:off x="218014" y="4073600"/>
                <a:ext cx="45717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err="1" smtClean="0">
                    <a:latin typeface="Arial" pitchFamily="34" charset="0"/>
                    <a:cs typeface="Arial" pitchFamily="34" charset="0"/>
                  </a:rPr>
                  <a:t>kDa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42" name="Straight Connector 41"/>
              <p:cNvCxnSpPr/>
              <p:nvPr/>
            </p:nvCxnSpPr>
            <p:spPr>
              <a:xfrm>
                <a:off x="512688" y="5593102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Straight Connector 42"/>
              <p:cNvCxnSpPr/>
              <p:nvPr/>
            </p:nvCxnSpPr>
            <p:spPr>
              <a:xfrm>
                <a:off x="512688" y="5928759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Straight Connector 43"/>
              <p:cNvCxnSpPr/>
              <p:nvPr/>
            </p:nvCxnSpPr>
            <p:spPr>
              <a:xfrm>
                <a:off x="512688" y="6309717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Connector 44"/>
              <p:cNvCxnSpPr/>
              <p:nvPr/>
            </p:nvCxnSpPr>
            <p:spPr>
              <a:xfrm>
                <a:off x="512688" y="5148064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" name="TextBox 45"/>
              <p:cNvSpPr txBox="1"/>
              <p:nvPr/>
            </p:nvSpPr>
            <p:spPr>
              <a:xfrm>
                <a:off x="260648" y="5017903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66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260648" y="5444756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45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260648" y="5795271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35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260648" y="6186053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25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50" name="Straight Connector 49"/>
              <p:cNvCxnSpPr/>
              <p:nvPr/>
            </p:nvCxnSpPr>
            <p:spPr>
              <a:xfrm>
                <a:off x="512688" y="4778499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" name="TextBox 50"/>
              <p:cNvSpPr txBox="1"/>
              <p:nvPr/>
            </p:nvSpPr>
            <p:spPr>
              <a:xfrm>
                <a:off x="198165" y="4644008"/>
                <a:ext cx="42813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116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52" name="TextBox 51"/>
          <p:cNvSpPr txBox="1"/>
          <p:nvPr/>
        </p:nvSpPr>
        <p:spPr>
          <a:xfrm>
            <a:off x="1685268" y="332656"/>
            <a:ext cx="118814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smtClean="0">
                <a:latin typeface="Arial" pitchFamily="34" charset="0"/>
                <a:cs typeface="Arial" pitchFamily="34" charset="0"/>
              </a:rPr>
              <a:t>NQO2-47F</a:t>
            </a:r>
            <a:endParaRPr lang="en-GB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6635435" y="332656"/>
            <a:ext cx="117692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smtClean="0">
                <a:latin typeface="Arial" pitchFamily="34" charset="0"/>
                <a:cs typeface="Arial" pitchFamily="34" charset="0"/>
              </a:rPr>
              <a:t>NQO2-47L</a:t>
            </a:r>
            <a:endParaRPr lang="en-GB" sz="16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490232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8</TotalTime>
  <Words>46</Words>
  <Application>Microsoft Office PowerPoint</Application>
  <PresentationFormat>On-screen Show (4:3)</PresentationFormat>
  <Paragraphs>2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lare Megarity</dc:creator>
  <cp:lastModifiedBy>2111446</cp:lastModifiedBy>
  <cp:revision>6</cp:revision>
  <dcterms:created xsi:type="dcterms:W3CDTF">2013-11-08T11:31:16Z</dcterms:created>
  <dcterms:modified xsi:type="dcterms:W3CDTF">2013-11-09T17:09:44Z</dcterms:modified>
</cp:coreProperties>
</file>